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093"/>
  </p:normalViewPr>
  <p:slideViewPr>
    <p:cSldViewPr snapToGrid="0" snapToObjects="1">
      <p:cViewPr varScale="1">
        <p:scale>
          <a:sx n="114" d="100"/>
          <a:sy n="114" d="100"/>
        </p:scale>
        <p:origin x="47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9DF1EC-6E7F-014D-8435-350DB4F5809D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DD3F0A-D04F-504F-807B-51BE79B3F1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6820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C67293-9105-504D-883E-19CF8D63223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7600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7845BB-C605-F24B-84D3-FCFC766917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59938C8-4182-B543-8715-40807491D4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D30B003-AD67-2841-81A9-E550543A7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F9D129D-1B65-4C4A-B095-1232EDEED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3A34D5B-1AF0-DA4B-8FF3-6E72E6E39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1609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538CD29-711D-1546-B57E-BEFE35C347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E532670-7F4F-984A-872E-09B4A9E8A5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C0951C9-57BF-7F4C-A62C-BA154083C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9358F6A-14B4-F946-A371-19F1F6C9C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324DDD9-B57B-994E-A102-9C15A26EA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2589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8255CE5-BD1B-BA48-9907-F4C2173E14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2C5C5F3-A6FD-BC41-8B14-7BBA35A5F2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C9453EB-C341-3948-BFAE-4F08449E2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C809A9A-6D7A-7044-B7CA-B7E024A9B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8AA9906-87CA-4B46-BA9D-2ACD0E50E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3669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18452C1-4732-FE4F-B79D-DFCF1C0FD1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2E361EA-32A7-C146-96B9-DFE60CB217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4E59779-B7F2-0D40-9B5D-3ECA78327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A82974-142C-2A48-BE76-95797469D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8DF7C7E-546E-6E4E-8741-846146A34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8229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D38A15-2B43-4846-B9A9-773AAC3D36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8D83BEB-0053-9F4A-A18E-27CA6ADF2B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F2760F6-0B7A-284A-B5CE-48DCCD2D2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B85EC65-09B6-5D41-B422-28F20C846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9BD0D93-554B-F249-9F67-BD377BCA7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6960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C064E72-2563-7C4A-BDCA-BAF1B15FF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6658474-4C64-D840-8E8A-76D9659856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E78BF7B-6C69-D543-B648-1BE42E458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AA21CA1-0AF7-F344-8BBC-245CD1591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2F0AD3A-E3B4-8F49-BD10-FB140A210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981F949-3D96-CD46-9E55-627740E04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4400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7C3FED-9727-534B-A934-795FA6E4D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D543123-E962-B64B-8323-2AABA4ACF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192A5D3-1401-8843-A606-1E4C938E3A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1308050-2133-F248-B488-705F152CD5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5A470CA-2C44-0744-BB94-4195218596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08A69CB-2C8E-E64F-9EE1-A6974A0AC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FDC8EA0-B324-5D41-8F8F-38C9FAB85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33D4D0A8-5BD9-1A40-9D90-09695ABB9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0504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58F81F-369A-DF41-808D-F62905930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AF7CF0E-38F5-1C42-BCF8-E92EA187D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EB44B44B-35F0-AC43-9837-E726C1C5C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1ED9C59-3D91-1241-B16A-6AC8EAAA5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5731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AEA0F5A-5C77-8B4A-AFC6-004030154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4715C49-F265-8541-91D2-2BC38DDF3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F43BB811-6279-6E4E-9A1A-2D8748AB7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0231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ECD52A7-61B5-4646-8EF1-C6B8A6347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C564FB6-D5A4-994E-8386-DB73F9396A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063BFC6-98D9-B841-A1CA-44CFE86827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3ED01C9-F91B-8F46-B204-2FE178009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E40B26A-42EF-3640-9C5B-D377CF546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939970F-04BE-F347-B289-D14109B28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3613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4BCB1A-4075-2F4E-992B-8616DDCC3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EDEF5E0-AFE6-D046-B2BA-8499D32E02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B81512B-0223-D54F-9F38-1B7A14ABF5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3DF3940-8D38-6844-A63B-9AF89E507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E01ED26-48DF-1343-BA2D-8CE7E8F7CF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3DC4481-46A2-4D45-A117-396EDD0C2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0978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494DDB44-C5AD-7F44-BB86-AF8E3C3EAC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4688E54-BFEE-4B42-B783-588D6F521A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BA4F998-7F49-034C-AC55-2FF37CC62B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F3B595-C9E6-5641-8B8A-EE1BCEE19D92}" type="datetimeFigureOut">
              <a:rPr lang="de-DE" smtClean="0"/>
              <a:t>14.06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54A5A05-03BA-DC43-AB24-A537C1B46D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F068565-4A59-B444-8DC4-263ACB22AD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30099-7F7F-424F-9549-AA665E276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001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ieren 19">
            <a:extLst>
              <a:ext uri="{FF2B5EF4-FFF2-40B4-BE49-F238E27FC236}">
                <a16:creationId xmlns:a16="http://schemas.microsoft.com/office/drawing/2014/main" id="{45DC989F-766A-EE4E-8E53-7D27C18FF1E8}"/>
              </a:ext>
            </a:extLst>
          </p:cNvPr>
          <p:cNvGrpSpPr/>
          <p:nvPr/>
        </p:nvGrpSpPr>
        <p:grpSpPr>
          <a:xfrm>
            <a:off x="452609" y="932243"/>
            <a:ext cx="10927495" cy="2800374"/>
            <a:chOff x="452609" y="932243"/>
            <a:chExt cx="10927495" cy="2800374"/>
          </a:xfrm>
        </p:grpSpPr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91EA35B3-A4AD-BC40-AA39-A5CC58B877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2609" y="978712"/>
              <a:ext cx="2685777" cy="2707436"/>
            </a:xfrm>
            <a:prstGeom prst="rect">
              <a:avLst/>
            </a:prstGeom>
          </p:spPr>
        </p:pic>
        <p:pic>
          <p:nvPicPr>
            <p:cNvPr id="15" name="Grafik 14">
              <a:extLst>
                <a:ext uri="{FF2B5EF4-FFF2-40B4-BE49-F238E27FC236}">
                  <a16:creationId xmlns:a16="http://schemas.microsoft.com/office/drawing/2014/main" id="{420497A8-7198-7845-A572-67A90F16971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38386" y="978712"/>
              <a:ext cx="2685777" cy="2707437"/>
            </a:xfrm>
            <a:prstGeom prst="rect">
              <a:avLst/>
            </a:prstGeom>
          </p:spPr>
        </p:pic>
        <p:pic>
          <p:nvPicPr>
            <p:cNvPr id="17" name="Grafik 16">
              <a:extLst>
                <a:ext uri="{FF2B5EF4-FFF2-40B4-BE49-F238E27FC236}">
                  <a16:creationId xmlns:a16="http://schemas.microsoft.com/office/drawing/2014/main" id="{80E42B22-91A7-5B48-A064-59AE4AC048D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24163" y="932243"/>
              <a:ext cx="2777970" cy="2800373"/>
            </a:xfrm>
            <a:prstGeom prst="rect">
              <a:avLst/>
            </a:prstGeom>
          </p:spPr>
        </p:pic>
        <p:pic>
          <p:nvPicPr>
            <p:cNvPr id="19" name="Grafik 18">
              <a:extLst>
                <a:ext uri="{FF2B5EF4-FFF2-40B4-BE49-F238E27FC236}">
                  <a16:creationId xmlns:a16="http://schemas.microsoft.com/office/drawing/2014/main" id="{F229BBB0-1303-154E-97D6-47FEF8FA2FB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602133" y="932243"/>
              <a:ext cx="2777971" cy="2800374"/>
            </a:xfrm>
            <a:prstGeom prst="rect">
              <a:avLst/>
            </a:prstGeom>
          </p:spPr>
        </p:pic>
      </p:grpSp>
      <p:sp>
        <p:nvSpPr>
          <p:cNvPr id="21" name="Textfeld 20">
            <a:extLst>
              <a:ext uri="{FF2B5EF4-FFF2-40B4-BE49-F238E27FC236}">
                <a16:creationId xmlns:a16="http://schemas.microsoft.com/office/drawing/2014/main" id="{803B04C4-F0E2-2143-839B-2D32FF5877A5}"/>
              </a:ext>
            </a:extLst>
          </p:cNvPr>
          <p:cNvSpPr txBox="1"/>
          <p:nvPr/>
        </p:nvSpPr>
        <p:spPr>
          <a:xfrm>
            <a:off x="359847" y="3961088"/>
            <a:ext cx="2802370" cy="1123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X-test</a:t>
            </a:r>
            <a:b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T 	60s 	(→38-65s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 	65mm 	(↑39-58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10 	70mm 	(↑47-64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0 	72mm 	(↑52-67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F 	72mm 	(↑53-68mm)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4409795C-5F07-584E-843C-01C64160A5A1}"/>
              </a:ext>
            </a:extLst>
          </p:cNvPr>
          <p:cNvSpPr txBox="1"/>
          <p:nvPr/>
        </p:nvSpPr>
        <p:spPr>
          <a:xfrm>
            <a:off x="3138386" y="3961088"/>
            <a:ext cx="2802370" cy="1123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IB-test</a:t>
            </a:r>
            <a:b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T 	79s 	(→55-87s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 	31mm 	(↑6 -21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10 	33mm 	(↑7-23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0 	35mm 	(↑8-25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F 	36mm 	(↑9-27mm)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83F6A46F-489D-CD41-8C24-631389095BD1}"/>
              </a:ext>
            </a:extLst>
          </p:cNvPr>
          <p:cNvSpPr txBox="1"/>
          <p:nvPr/>
        </p:nvSpPr>
        <p:spPr>
          <a:xfrm>
            <a:off x="5824163" y="3961088"/>
            <a:ext cx="3007555" cy="1123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IN-test</a:t>
            </a:r>
            <a:b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 	304s 	(↑139-187s)</a:t>
            </a:r>
          </a:p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5 	51mm 	(→32 -53mm)</a:t>
            </a:r>
          </a:p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10 	60mm 	(→41-61mm)</a:t>
            </a:r>
          </a:p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20 	64mm 	(→48-65mm)</a:t>
            </a:r>
          </a:p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MCF 	65mm 	(→49-65mm)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F4D2CD2-E475-0C47-90B8-E9A20D545989}"/>
              </a:ext>
            </a:extLst>
          </p:cNvPr>
          <p:cNvSpPr txBox="1"/>
          <p:nvPr/>
        </p:nvSpPr>
        <p:spPr>
          <a:xfrm>
            <a:off x="8602133" y="3961088"/>
            <a:ext cx="2853666" cy="12926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I-test</a:t>
            </a:r>
            <a:b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T 	167s 	(→141-185s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 	60mm 	(↑36-56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10 	65mm 	(↑45-61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0 	69mm 	(↑49-65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F 	69mm 	(↑49-65mm)</a:t>
            </a:r>
          </a:p>
          <a:p>
            <a:r>
              <a:rPr lang="de-DE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 	2% 	(↓2-13%)</a:t>
            </a:r>
          </a:p>
        </p:txBody>
      </p:sp>
    </p:spTree>
    <p:extLst>
      <p:ext uri="{BB962C8B-B14F-4D97-AF65-F5344CB8AC3E}">
        <p14:creationId xmlns:p14="http://schemas.microsoft.com/office/powerpoint/2010/main" val="2467325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Macintosh PowerPoint</Application>
  <PresentationFormat>Breitbild</PresentationFormat>
  <Paragraphs>2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rolin Jung</dc:creator>
  <cp:lastModifiedBy>Carolin Jung</cp:lastModifiedBy>
  <cp:revision>1</cp:revision>
  <dcterms:created xsi:type="dcterms:W3CDTF">2021-06-14T18:16:05Z</dcterms:created>
  <dcterms:modified xsi:type="dcterms:W3CDTF">2021-06-14T18:16:50Z</dcterms:modified>
</cp:coreProperties>
</file>